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handoutMasterIdLst>
    <p:handoutMasterId r:id="rId3"/>
  </p:handoutMasterIdLst>
  <p:sldIdLst>
    <p:sldId id="267" r:id="rId2"/>
  </p:sldIdLst>
  <p:sldSz cx="6858000" cy="9144000" type="screen4x3"/>
  <p:notesSz cx="9926638" cy="67976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1" autoAdjust="0"/>
    <p:restoredTop sz="94676" autoAdjust="0"/>
  </p:normalViewPr>
  <p:slideViewPr>
    <p:cSldViewPr>
      <p:cViewPr>
        <p:scale>
          <a:sx n="100" d="100"/>
          <a:sy n="100" d="100"/>
        </p:scale>
        <p:origin x="-1452" y="654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handoutMaster" Target="handoutMasters/handout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5621696" y="0"/>
            <a:ext cx="4302625" cy="34026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AFE555D-ECA8-4B05-BB7B-46DB13C02D3B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5621696" y="6456324"/>
            <a:ext cx="4302625" cy="34026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61A6C07-1ED5-48E5-9F9F-17C16A106B5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183203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80979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305272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29336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105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13122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0525676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36788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06736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849498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113844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23970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C540B43-3877-4D1A-B370-5D57BA53EA63}" type="datetimeFigureOut">
              <a:rPr lang="en-GB" smtClean="0"/>
              <a:t>27/03/201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399FED-2DD8-474C-9C92-34A22B64534D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08610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332656" y="1331640"/>
            <a:ext cx="631644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dirty="0" smtClean="0"/>
              <a:t>Supplementary Table 4: Block effects across the two trials.  For the mixed population </a:t>
            </a:r>
            <a:r>
              <a:rPr lang="en-GB" sz="1200" i="1" dirty="0" smtClean="0"/>
              <a:t>n</a:t>
            </a:r>
            <a:r>
              <a:rPr lang="en-GB" sz="1200" dirty="0" smtClean="0"/>
              <a:t>= 18 and for the mapping family </a:t>
            </a:r>
            <a:r>
              <a:rPr lang="en-GB" sz="1200" i="1" dirty="0" smtClean="0"/>
              <a:t>n</a:t>
            </a:r>
            <a:r>
              <a:rPr lang="en-GB" sz="1200" dirty="0" smtClean="0"/>
              <a:t>=19.  Statistics (</a:t>
            </a:r>
            <a:r>
              <a:rPr lang="en-GB" sz="1200" i="1" dirty="0" smtClean="0"/>
              <a:t>F</a:t>
            </a:r>
            <a:r>
              <a:rPr lang="en-GB" sz="1200" dirty="0" smtClean="0"/>
              <a:t> </a:t>
            </a:r>
            <a:r>
              <a:rPr lang="en-GB" sz="1200" dirty="0" err="1" smtClean="0"/>
              <a:t>Pr</a:t>
            </a:r>
            <a:r>
              <a:rPr lang="en-GB" sz="1200" dirty="0" smtClean="0"/>
              <a:t>) show the results of a one way ANOVA with block as a treatment factor (Significant differences = </a:t>
            </a:r>
            <a:r>
              <a:rPr lang="en-GB" sz="1200" dirty="0"/>
              <a:t>≤ 0.05</a:t>
            </a:r>
            <a:r>
              <a:rPr lang="en-GB" sz="1200" dirty="0" smtClean="0"/>
              <a:t>).</a:t>
            </a:r>
            <a:endParaRPr lang="en-GB" sz="1200" dirty="0"/>
          </a:p>
        </p:txBody>
      </p:sp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96500636"/>
              </p:ext>
            </p:extLst>
          </p:nvPr>
        </p:nvGraphicFramePr>
        <p:xfrm>
          <a:off x="332656" y="2123728"/>
          <a:ext cx="6172200" cy="2021573"/>
        </p:xfrm>
        <a:graphic>
          <a:graphicData uri="http://schemas.openxmlformats.org/drawingml/2006/table">
            <a:tbl>
              <a:tblPr/>
              <a:tblGrid>
                <a:gridCol w="708807"/>
                <a:gridCol w="254852"/>
                <a:gridCol w="113489"/>
                <a:gridCol w="230960"/>
                <a:gridCol w="250870"/>
                <a:gridCol w="113489"/>
                <a:gridCol w="226978"/>
                <a:gridCol w="268789"/>
                <a:gridCol w="113489"/>
                <a:gridCol w="230960"/>
                <a:gridCol w="382278"/>
                <a:gridCol w="382278"/>
                <a:gridCol w="708807"/>
                <a:gridCol w="254852"/>
                <a:gridCol w="113489"/>
                <a:gridCol w="230960"/>
                <a:gridCol w="250870"/>
                <a:gridCol w="113489"/>
                <a:gridCol w="226978"/>
                <a:gridCol w="268789"/>
                <a:gridCol w="113489"/>
                <a:gridCol w="230960"/>
                <a:gridCol w="382278"/>
              </a:tblGrid>
              <a:tr h="119308"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ixed Population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4">
                  <a:txBody>
                    <a:bodyPr/>
                    <a:lstStyle/>
                    <a:p>
                      <a:pPr algn="l" fontAlgn="b"/>
                      <a:r>
                        <a:rPr lang="en-GB" sz="700" b="1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pping Family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n-structural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n-structural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bohydrat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Pr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arbohydrat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Pr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5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8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uct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7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ruct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0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9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cr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.5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.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7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ucr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.0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68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ch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.6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7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tarch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0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4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1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8.6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6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0956"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Wall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 Wall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lock 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mposit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 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Pr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omposite:</a:t>
                      </a:r>
                      <a:endParaRPr lang="en-GB" sz="7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ean 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.E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F Pr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bin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.4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rabin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7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7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lact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21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alact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76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0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9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Gluc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.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40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8.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0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2.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8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9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Xyl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7.3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5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8.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2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nn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0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01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nn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3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ul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6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46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0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ellulose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0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96.5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2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7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0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19308"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gni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0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9.7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&lt;.001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7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Lignin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.8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0.2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9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1.4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±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GB" sz="7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4</a:t>
                      </a:r>
                    </a:p>
                  </a:txBody>
                  <a:tcPr marL="5965" marR="5965" marT="5965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7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0.119</a:t>
                      </a:r>
                    </a:p>
                  </a:txBody>
                  <a:tcPr marL="5965" marR="5965" marT="596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767609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55</TotalTime>
  <Words>373</Words>
  <Application>Microsoft Office PowerPoint</Application>
  <PresentationFormat>On-screen Show (4:3)</PresentationFormat>
  <Paragraphs>298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Aberystwyth Universit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p</dc:creator>
  <cp:lastModifiedBy>sap</cp:lastModifiedBy>
  <cp:revision>83</cp:revision>
  <cp:lastPrinted>2015-03-27T09:20:34Z</cp:lastPrinted>
  <dcterms:created xsi:type="dcterms:W3CDTF">2014-04-04T15:40:13Z</dcterms:created>
  <dcterms:modified xsi:type="dcterms:W3CDTF">2015-03-27T13:31:51Z</dcterms:modified>
</cp:coreProperties>
</file>